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36152138" cy="51120675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yunaisec" initials="s" lastIdx="1" clrIdx="0">
    <p:extLst>
      <p:ext uri="{19B8F6BF-5375-455C-9EA6-DF929625EA0E}">
        <p15:presenceInfo xmlns:p15="http://schemas.microsoft.com/office/powerpoint/2012/main" userId="syunaise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テーマ スタイル 2 - アクセント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1" autoAdjust="0"/>
    <p:restoredTop sz="95394" autoAdjust="0"/>
  </p:normalViewPr>
  <p:slideViewPr>
    <p:cSldViewPr snapToGrid="0">
      <p:cViewPr varScale="1">
        <p:scale>
          <a:sx n="15" d="100"/>
          <a:sy n="15" d="100"/>
        </p:scale>
        <p:origin x="31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0CCA0A-2098-40F2-96C5-D11E4DB2957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243013"/>
            <a:ext cx="23717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419F07-D54D-4B42-AE3E-71ABD822AF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935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1pPr>
    <a:lvl2pPr marL="2453792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2pPr>
    <a:lvl3pPr marL="4907585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3pPr>
    <a:lvl4pPr marL="7361377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4pPr>
    <a:lvl5pPr marL="9815170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5pPr>
    <a:lvl6pPr marL="12268962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6pPr>
    <a:lvl7pPr marL="14722754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7pPr>
    <a:lvl8pPr marL="17176547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8pPr>
    <a:lvl9pPr marL="19630339" algn="l" defTabSz="4907585" rtl="0" eaLnBrk="1" latinLnBrk="0" hangingPunct="1">
      <a:defRPr kumimoji="1" sz="64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11411" y="8366281"/>
            <a:ext cx="30729317" cy="17797568"/>
          </a:xfrm>
        </p:spPr>
        <p:txBody>
          <a:bodyPr anchor="b"/>
          <a:lstStyle>
            <a:lvl1pPr algn="ctr">
              <a:defRPr sz="237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19017" y="26850192"/>
            <a:ext cx="27114104" cy="12342326"/>
          </a:xfrm>
        </p:spPr>
        <p:txBody>
          <a:bodyPr/>
          <a:lstStyle>
            <a:lvl1pPr marL="0" indent="0" algn="ctr">
              <a:buNone/>
              <a:defRPr sz="9489"/>
            </a:lvl1pPr>
            <a:lvl2pPr marL="1807586" indent="0" algn="ctr">
              <a:buNone/>
              <a:defRPr sz="7907"/>
            </a:lvl2pPr>
            <a:lvl3pPr marL="3615172" indent="0" algn="ctr">
              <a:buNone/>
              <a:defRPr sz="7116"/>
            </a:lvl3pPr>
            <a:lvl4pPr marL="5422758" indent="0" algn="ctr">
              <a:buNone/>
              <a:defRPr sz="6326"/>
            </a:lvl4pPr>
            <a:lvl5pPr marL="7230344" indent="0" algn="ctr">
              <a:buNone/>
              <a:defRPr sz="6326"/>
            </a:lvl5pPr>
            <a:lvl6pPr marL="9037930" indent="0" algn="ctr">
              <a:buNone/>
              <a:defRPr sz="6326"/>
            </a:lvl6pPr>
            <a:lvl7pPr marL="10845516" indent="0" algn="ctr">
              <a:buNone/>
              <a:defRPr sz="6326"/>
            </a:lvl7pPr>
            <a:lvl8pPr marL="12653101" indent="0" algn="ctr">
              <a:buNone/>
              <a:defRPr sz="6326"/>
            </a:lvl8pPr>
            <a:lvl9pPr marL="14460687" indent="0" algn="ctr">
              <a:buNone/>
              <a:defRPr sz="632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897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70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871376" y="2721703"/>
            <a:ext cx="7795305" cy="433224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85461" y="2721703"/>
            <a:ext cx="22934013" cy="433224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541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870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66632" y="12744683"/>
            <a:ext cx="31181219" cy="21264777"/>
          </a:xfrm>
        </p:spPr>
        <p:txBody>
          <a:bodyPr anchor="b"/>
          <a:lstStyle>
            <a:lvl1pPr>
              <a:defRPr sz="237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66632" y="34210633"/>
            <a:ext cx="31181219" cy="11182644"/>
          </a:xfrm>
        </p:spPr>
        <p:txBody>
          <a:bodyPr/>
          <a:lstStyle>
            <a:lvl1pPr marL="0" indent="0">
              <a:buNone/>
              <a:defRPr sz="9489">
                <a:solidFill>
                  <a:schemeClr val="tx1"/>
                </a:solidFill>
              </a:defRPr>
            </a:lvl1pPr>
            <a:lvl2pPr marL="1807586" indent="0">
              <a:buNone/>
              <a:defRPr sz="7907">
                <a:solidFill>
                  <a:schemeClr val="tx1">
                    <a:tint val="75000"/>
                  </a:schemeClr>
                </a:solidFill>
              </a:defRPr>
            </a:lvl2pPr>
            <a:lvl3pPr marL="3615172" indent="0">
              <a:buNone/>
              <a:defRPr sz="7116">
                <a:solidFill>
                  <a:schemeClr val="tx1">
                    <a:tint val="75000"/>
                  </a:schemeClr>
                </a:solidFill>
              </a:defRPr>
            </a:lvl3pPr>
            <a:lvl4pPr marL="5422758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4pPr>
            <a:lvl5pPr marL="7230344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5pPr>
            <a:lvl6pPr marL="9037930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6pPr>
            <a:lvl7pPr marL="10845516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7pPr>
            <a:lvl8pPr marL="12653101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8pPr>
            <a:lvl9pPr marL="14460687" indent="0">
              <a:buNone/>
              <a:defRPr sz="63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836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85459" y="13608513"/>
            <a:ext cx="15364659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302020" y="13608513"/>
            <a:ext cx="15364659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199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8" y="2721714"/>
            <a:ext cx="31181219" cy="98809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0172" y="12531669"/>
            <a:ext cx="15294047" cy="6141577"/>
          </a:xfrm>
        </p:spPr>
        <p:txBody>
          <a:bodyPr anchor="b"/>
          <a:lstStyle>
            <a:lvl1pPr marL="0" indent="0">
              <a:buNone/>
              <a:defRPr sz="9489" b="1"/>
            </a:lvl1pPr>
            <a:lvl2pPr marL="1807586" indent="0">
              <a:buNone/>
              <a:defRPr sz="7907" b="1"/>
            </a:lvl2pPr>
            <a:lvl3pPr marL="3615172" indent="0">
              <a:buNone/>
              <a:defRPr sz="7116" b="1"/>
            </a:lvl3pPr>
            <a:lvl4pPr marL="5422758" indent="0">
              <a:buNone/>
              <a:defRPr sz="6326" b="1"/>
            </a:lvl4pPr>
            <a:lvl5pPr marL="7230344" indent="0">
              <a:buNone/>
              <a:defRPr sz="6326" b="1"/>
            </a:lvl5pPr>
            <a:lvl6pPr marL="9037930" indent="0">
              <a:buNone/>
              <a:defRPr sz="6326" b="1"/>
            </a:lvl6pPr>
            <a:lvl7pPr marL="10845516" indent="0">
              <a:buNone/>
              <a:defRPr sz="6326" b="1"/>
            </a:lvl7pPr>
            <a:lvl8pPr marL="12653101" indent="0">
              <a:buNone/>
              <a:defRPr sz="6326" b="1"/>
            </a:lvl8pPr>
            <a:lvl9pPr marL="14460687" indent="0">
              <a:buNone/>
              <a:defRPr sz="632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90172" y="18673247"/>
            <a:ext cx="15294047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302022" y="12531669"/>
            <a:ext cx="15369367" cy="6141577"/>
          </a:xfrm>
        </p:spPr>
        <p:txBody>
          <a:bodyPr anchor="b"/>
          <a:lstStyle>
            <a:lvl1pPr marL="0" indent="0">
              <a:buNone/>
              <a:defRPr sz="9489" b="1"/>
            </a:lvl1pPr>
            <a:lvl2pPr marL="1807586" indent="0">
              <a:buNone/>
              <a:defRPr sz="7907" b="1"/>
            </a:lvl2pPr>
            <a:lvl3pPr marL="3615172" indent="0">
              <a:buNone/>
              <a:defRPr sz="7116" b="1"/>
            </a:lvl3pPr>
            <a:lvl4pPr marL="5422758" indent="0">
              <a:buNone/>
              <a:defRPr sz="6326" b="1"/>
            </a:lvl4pPr>
            <a:lvl5pPr marL="7230344" indent="0">
              <a:buNone/>
              <a:defRPr sz="6326" b="1"/>
            </a:lvl5pPr>
            <a:lvl6pPr marL="9037930" indent="0">
              <a:buNone/>
              <a:defRPr sz="6326" b="1"/>
            </a:lvl6pPr>
            <a:lvl7pPr marL="10845516" indent="0">
              <a:buNone/>
              <a:defRPr sz="6326" b="1"/>
            </a:lvl7pPr>
            <a:lvl8pPr marL="12653101" indent="0">
              <a:buNone/>
              <a:defRPr sz="6326" b="1"/>
            </a:lvl8pPr>
            <a:lvl9pPr marL="14460687" indent="0">
              <a:buNone/>
              <a:defRPr sz="632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302022" y="18673247"/>
            <a:ext cx="15369367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659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15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876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9" y="3408045"/>
            <a:ext cx="11660005" cy="11928158"/>
          </a:xfrm>
        </p:spPr>
        <p:txBody>
          <a:bodyPr anchor="b"/>
          <a:lstStyle>
            <a:lvl1pPr>
              <a:defRPr sz="126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69367" y="7360442"/>
            <a:ext cx="18302020" cy="36328813"/>
          </a:xfrm>
        </p:spPr>
        <p:txBody>
          <a:bodyPr/>
          <a:lstStyle>
            <a:lvl1pPr>
              <a:defRPr sz="12652"/>
            </a:lvl1pPr>
            <a:lvl2pPr>
              <a:defRPr sz="11070"/>
            </a:lvl2pPr>
            <a:lvl3pPr>
              <a:defRPr sz="9489"/>
            </a:lvl3pPr>
            <a:lvl4pPr>
              <a:defRPr sz="7907"/>
            </a:lvl4pPr>
            <a:lvl5pPr>
              <a:defRPr sz="7907"/>
            </a:lvl5pPr>
            <a:lvl6pPr>
              <a:defRPr sz="7907"/>
            </a:lvl6pPr>
            <a:lvl7pPr>
              <a:defRPr sz="7907"/>
            </a:lvl7pPr>
            <a:lvl8pPr>
              <a:defRPr sz="7907"/>
            </a:lvl8pPr>
            <a:lvl9pPr>
              <a:defRPr sz="790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90169" y="15336203"/>
            <a:ext cx="11660005" cy="28412212"/>
          </a:xfrm>
        </p:spPr>
        <p:txBody>
          <a:bodyPr/>
          <a:lstStyle>
            <a:lvl1pPr marL="0" indent="0">
              <a:buNone/>
              <a:defRPr sz="6326"/>
            </a:lvl1pPr>
            <a:lvl2pPr marL="1807586" indent="0">
              <a:buNone/>
              <a:defRPr sz="5535"/>
            </a:lvl2pPr>
            <a:lvl3pPr marL="3615172" indent="0">
              <a:buNone/>
              <a:defRPr sz="4744"/>
            </a:lvl3pPr>
            <a:lvl4pPr marL="5422758" indent="0">
              <a:buNone/>
              <a:defRPr sz="3954"/>
            </a:lvl4pPr>
            <a:lvl5pPr marL="7230344" indent="0">
              <a:buNone/>
              <a:defRPr sz="3954"/>
            </a:lvl5pPr>
            <a:lvl6pPr marL="9037930" indent="0">
              <a:buNone/>
              <a:defRPr sz="3954"/>
            </a:lvl6pPr>
            <a:lvl7pPr marL="10845516" indent="0">
              <a:buNone/>
              <a:defRPr sz="3954"/>
            </a:lvl7pPr>
            <a:lvl8pPr marL="12653101" indent="0">
              <a:buNone/>
              <a:defRPr sz="3954"/>
            </a:lvl8pPr>
            <a:lvl9pPr marL="14460687" indent="0">
              <a:buNone/>
              <a:defRPr sz="39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537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0169" y="3408045"/>
            <a:ext cx="11660005" cy="11928158"/>
          </a:xfrm>
        </p:spPr>
        <p:txBody>
          <a:bodyPr anchor="b"/>
          <a:lstStyle>
            <a:lvl1pPr>
              <a:defRPr sz="126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69367" y="7360442"/>
            <a:ext cx="18302020" cy="36328813"/>
          </a:xfrm>
        </p:spPr>
        <p:txBody>
          <a:bodyPr anchor="t"/>
          <a:lstStyle>
            <a:lvl1pPr marL="0" indent="0">
              <a:buNone/>
              <a:defRPr sz="12652"/>
            </a:lvl1pPr>
            <a:lvl2pPr marL="1807586" indent="0">
              <a:buNone/>
              <a:defRPr sz="11070"/>
            </a:lvl2pPr>
            <a:lvl3pPr marL="3615172" indent="0">
              <a:buNone/>
              <a:defRPr sz="9489"/>
            </a:lvl3pPr>
            <a:lvl4pPr marL="5422758" indent="0">
              <a:buNone/>
              <a:defRPr sz="7907"/>
            </a:lvl4pPr>
            <a:lvl5pPr marL="7230344" indent="0">
              <a:buNone/>
              <a:defRPr sz="7907"/>
            </a:lvl5pPr>
            <a:lvl6pPr marL="9037930" indent="0">
              <a:buNone/>
              <a:defRPr sz="7907"/>
            </a:lvl6pPr>
            <a:lvl7pPr marL="10845516" indent="0">
              <a:buNone/>
              <a:defRPr sz="7907"/>
            </a:lvl7pPr>
            <a:lvl8pPr marL="12653101" indent="0">
              <a:buNone/>
              <a:defRPr sz="7907"/>
            </a:lvl8pPr>
            <a:lvl9pPr marL="14460687" indent="0">
              <a:buNone/>
              <a:defRPr sz="7907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90169" y="15336203"/>
            <a:ext cx="11660005" cy="28412212"/>
          </a:xfrm>
        </p:spPr>
        <p:txBody>
          <a:bodyPr/>
          <a:lstStyle>
            <a:lvl1pPr marL="0" indent="0">
              <a:buNone/>
              <a:defRPr sz="6326"/>
            </a:lvl1pPr>
            <a:lvl2pPr marL="1807586" indent="0">
              <a:buNone/>
              <a:defRPr sz="5535"/>
            </a:lvl2pPr>
            <a:lvl3pPr marL="3615172" indent="0">
              <a:buNone/>
              <a:defRPr sz="4744"/>
            </a:lvl3pPr>
            <a:lvl4pPr marL="5422758" indent="0">
              <a:buNone/>
              <a:defRPr sz="3954"/>
            </a:lvl4pPr>
            <a:lvl5pPr marL="7230344" indent="0">
              <a:buNone/>
              <a:defRPr sz="3954"/>
            </a:lvl5pPr>
            <a:lvl6pPr marL="9037930" indent="0">
              <a:buNone/>
              <a:defRPr sz="3954"/>
            </a:lvl6pPr>
            <a:lvl7pPr marL="10845516" indent="0">
              <a:buNone/>
              <a:defRPr sz="3954"/>
            </a:lvl7pPr>
            <a:lvl8pPr marL="12653101" indent="0">
              <a:buNone/>
              <a:defRPr sz="3954"/>
            </a:lvl8pPr>
            <a:lvl9pPr marL="14460687" indent="0">
              <a:buNone/>
              <a:defRPr sz="39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990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85460" y="2721714"/>
            <a:ext cx="31181219" cy="9880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85460" y="13608513"/>
            <a:ext cx="31181219" cy="324355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85460" y="47381303"/>
            <a:ext cx="8134231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DB5E8-7F1D-4D4A-BF31-59CD61463A24}" type="datetimeFigureOut">
              <a:rPr kumimoji="1" lang="ja-JP" altLang="en-US" smtClean="0"/>
              <a:t>2021/5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75396" y="47381303"/>
            <a:ext cx="12201347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532447" y="47381303"/>
            <a:ext cx="8134231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9423D-0300-4726-B9C6-00DF37BC2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723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615172" rtl="0" eaLnBrk="1" latinLnBrk="0" hangingPunct="1">
        <a:lnSpc>
          <a:spcPct val="90000"/>
        </a:lnSpc>
        <a:spcBef>
          <a:spcPct val="0"/>
        </a:spcBef>
        <a:buNone/>
        <a:defRPr kumimoji="1" sz="173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3793" indent="-903793" algn="l" defTabSz="3615172" rtl="0" eaLnBrk="1" latinLnBrk="0" hangingPunct="1">
        <a:lnSpc>
          <a:spcPct val="90000"/>
        </a:lnSpc>
        <a:spcBef>
          <a:spcPts val="3954"/>
        </a:spcBef>
        <a:buFont typeface="Arial" panose="020B0604020202020204" pitchFamily="34" charset="0"/>
        <a:buChar char="•"/>
        <a:defRPr kumimoji="1" sz="11070" kern="1200">
          <a:solidFill>
            <a:schemeClr val="tx1"/>
          </a:solidFill>
          <a:latin typeface="+mn-lt"/>
          <a:ea typeface="+mn-ea"/>
          <a:cs typeface="+mn-cs"/>
        </a:defRPr>
      </a:lvl1pPr>
      <a:lvl2pPr marL="2711379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9489" kern="1200">
          <a:solidFill>
            <a:schemeClr val="tx1"/>
          </a:solidFill>
          <a:latin typeface="+mn-lt"/>
          <a:ea typeface="+mn-ea"/>
          <a:cs typeface="+mn-cs"/>
        </a:defRPr>
      </a:lvl2pPr>
      <a:lvl3pPr marL="4518965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907" kern="1200">
          <a:solidFill>
            <a:schemeClr val="tx1"/>
          </a:solidFill>
          <a:latin typeface="+mn-lt"/>
          <a:ea typeface="+mn-ea"/>
          <a:cs typeface="+mn-cs"/>
        </a:defRPr>
      </a:lvl3pPr>
      <a:lvl4pPr marL="6326551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4pPr>
      <a:lvl5pPr marL="8134137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5pPr>
      <a:lvl6pPr marL="9941723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6pPr>
      <a:lvl7pPr marL="11749308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7pPr>
      <a:lvl8pPr marL="13556894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8pPr>
      <a:lvl9pPr marL="15364480" indent="-903793" algn="l" defTabSz="3615172" rtl="0" eaLnBrk="1" latinLnBrk="0" hangingPunct="1">
        <a:lnSpc>
          <a:spcPct val="90000"/>
        </a:lnSpc>
        <a:spcBef>
          <a:spcPts val="1977"/>
        </a:spcBef>
        <a:buFont typeface="Arial" panose="020B0604020202020204" pitchFamily="34" charset="0"/>
        <a:buChar char="•"/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1pPr>
      <a:lvl2pPr marL="1807586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2pPr>
      <a:lvl3pPr marL="3615172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3pPr>
      <a:lvl4pPr marL="5422758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4pPr>
      <a:lvl5pPr marL="7230344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5pPr>
      <a:lvl6pPr marL="9037930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6pPr>
      <a:lvl7pPr marL="10845516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7pPr>
      <a:lvl8pPr marL="12653101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8pPr>
      <a:lvl9pPr marL="14460687" algn="l" defTabSz="3615172" rtl="0" eaLnBrk="1" latinLnBrk="0" hangingPunct="1">
        <a:defRPr kumimoji="1" sz="71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/>
          <p:cNvSpPr txBox="1"/>
          <p:nvPr/>
        </p:nvSpPr>
        <p:spPr>
          <a:xfrm>
            <a:off x="1681428" y="3403178"/>
            <a:ext cx="6832659" cy="106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326" b="1" dirty="0">
                <a:latin typeface="Arial" pitchFamily="34" charset="0"/>
                <a:cs typeface="Arial" pitchFamily="34" charset="0"/>
              </a:rPr>
              <a:t>Figure 3D</a:t>
            </a:r>
            <a:endParaRPr kumimoji="1" lang="ja-JP" altLang="en-US" sz="6326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" name="グループ化 64"/>
          <p:cNvGrpSpPr/>
          <p:nvPr/>
        </p:nvGrpSpPr>
        <p:grpSpPr>
          <a:xfrm>
            <a:off x="7067899" y="34728711"/>
            <a:ext cx="15551218" cy="14366342"/>
            <a:chOff x="1340768" y="5951185"/>
            <a:chExt cx="2950040" cy="2725271"/>
          </a:xfrm>
        </p:grpSpPr>
        <p:pic>
          <p:nvPicPr>
            <p:cNvPr id="1026" name="Picture 2" descr="C:\Users\Yuta Onodera\Desktop\2019.05.16 Folr1 CoIP FRa Whole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924944" y="7164288"/>
              <a:ext cx="1173163" cy="1362075"/>
            </a:xfrm>
            <a:prstGeom prst="rect">
              <a:avLst/>
            </a:prstGeom>
            <a:noFill/>
          </p:spPr>
        </p:pic>
        <p:sp>
          <p:nvSpPr>
            <p:cNvPr id="5" name="テキスト ボックス 4"/>
            <p:cNvSpPr txBox="1"/>
            <p:nvPr/>
          </p:nvSpPr>
          <p:spPr>
            <a:xfrm rot="16200000">
              <a:off x="2797757" y="6626779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IgG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 rot="16200000">
              <a:off x="3032415" y="6616907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FOLRα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二等辺三角形 8"/>
            <p:cNvSpPr/>
            <p:nvPr/>
          </p:nvSpPr>
          <p:spPr>
            <a:xfrm>
              <a:off x="4146792" y="7608528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0" name="二等辺三角形 9"/>
            <p:cNvSpPr/>
            <p:nvPr/>
          </p:nvSpPr>
          <p:spPr>
            <a:xfrm>
              <a:off x="3225168" y="8532440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1" name="二等辺三角形 10"/>
            <p:cNvSpPr/>
            <p:nvPr/>
          </p:nvSpPr>
          <p:spPr>
            <a:xfrm>
              <a:off x="3452240" y="8532440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361072" y="790875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361072" y="762072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2361072" y="738031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48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361072" y="723629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63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2361072" y="709228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348880" y="687625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1" name="直線コネクタ 20"/>
            <p:cNvCxnSpPr/>
            <p:nvPr/>
          </p:nvCxnSpPr>
          <p:spPr>
            <a:xfrm>
              <a:off x="3222880" y="6468592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/>
            <p:cNvSpPr txBox="1"/>
            <p:nvPr/>
          </p:nvSpPr>
          <p:spPr>
            <a:xfrm>
              <a:off x="3088768" y="626476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coIP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1340768" y="5951185"/>
              <a:ext cx="182458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FOLRα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 (44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6" name="グループ化 65"/>
          <p:cNvGrpSpPr/>
          <p:nvPr/>
        </p:nvGrpSpPr>
        <p:grpSpPr>
          <a:xfrm>
            <a:off x="7067899" y="19107270"/>
            <a:ext cx="18220424" cy="14424503"/>
            <a:chOff x="1340768" y="2843808"/>
            <a:chExt cx="3456384" cy="2736304"/>
          </a:xfrm>
        </p:grpSpPr>
        <p:sp>
          <p:nvSpPr>
            <p:cNvPr id="42" name="二等辺三角形 41"/>
            <p:cNvSpPr/>
            <p:nvPr/>
          </p:nvSpPr>
          <p:spPr>
            <a:xfrm>
              <a:off x="3727102" y="543609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3" name="二等辺三角形 42"/>
            <p:cNvSpPr/>
            <p:nvPr/>
          </p:nvSpPr>
          <p:spPr>
            <a:xfrm>
              <a:off x="3954174" y="543609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1340768" y="2843808"/>
              <a:ext cx="129614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PHB2 (35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9" name="Picture 5" descr="C:\Users\Yuta Onodera\Desktop\2019.05.17 Folr1 CoIP PHB2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503944" y="3922784"/>
              <a:ext cx="2171700" cy="1479550"/>
            </a:xfrm>
            <a:prstGeom prst="rect">
              <a:avLst/>
            </a:prstGeom>
            <a:noFill/>
          </p:spPr>
        </p:pic>
        <p:sp>
          <p:nvSpPr>
            <p:cNvPr id="52" name="テキスト ボックス 51"/>
            <p:cNvSpPr txBox="1"/>
            <p:nvPr/>
          </p:nvSpPr>
          <p:spPr>
            <a:xfrm>
              <a:off x="1941216" y="477583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1941216" y="448780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1941216" y="424739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48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1941216" y="410337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63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1941216" y="395936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1929024" y="374333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 rot="16200000">
              <a:off x="3277429" y="3374227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IgG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 rot="16200000">
              <a:off x="3512087" y="3364355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FOLRα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2" name="直線コネクタ 61"/>
            <p:cNvCxnSpPr/>
            <p:nvPr/>
          </p:nvCxnSpPr>
          <p:spPr>
            <a:xfrm>
              <a:off x="3702552" y="3216040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テキスト ボックス 62"/>
            <p:cNvSpPr txBox="1"/>
            <p:nvPr/>
          </p:nvSpPr>
          <p:spPr>
            <a:xfrm>
              <a:off x="3568440" y="3012208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coIP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二等辺三角形 63"/>
            <p:cNvSpPr/>
            <p:nvPr/>
          </p:nvSpPr>
          <p:spPr>
            <a:xfrm>
              <a:off x="4653136" y="4524376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</p:grpSp>
      <p:grpSp>
        <p:nvGrpSpPr>
          <p:cNvPr id="72" name="グループ化 71"/>
          <p:cNvGrpSpPr/>
          <p:nvPr/>
        </p:nvGrpSpPr>
        <p:grpSpPr>
          <a:xfrm>
            <a:off x="7067898" y="3543991"/>
            <a:ext cx="18150123" cy="14804095"/>
            <a:chOff x="1340768" y="395536"/>
            <a:chExt cx="3443048" cy="2808312"/>
          </a:xfrm>
        </p:grpSpPr>
        <p:pic>
          <p:nvPicPr>
            <p:cNvPr id="1030" name="Picture 6" descr="C:\Users\Yuta Onodera\Desktop\2019.05.15 FRa CoIP PHB1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467368" y="1541803"/>
              <a:ext cx="2219326" cy="1508125"/>
            </a:xfrm>
            <a:prstGeom prst="rect">
              <a:avLst/>
            </a:prstGeom>
            <a:noFill/>
          </p:spPr>
        </p:pic>
        <p:sp>
          <p:nvSpPr>
            <p:cNvPr id="27" name="テキスト ボックス 26"/>
            <p:cNvSpPr txBox="1"/>
            <p:nvPr/>
          </p:nvSpPr>
          <p:spPr>
            <a:xfrm rot="16200000">
              <a:off x="3258281" y="1014762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IgG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 rot="16200000">
              <a:off x="3492939" y="1004890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 err="1">
                  <a:latin typeface="Arial" pitchFamily="34" charset="0"/>
                  <a:cs typeface="Arial" pitchFamily="34" charset="0"/>
                </a:rPr>
                <a:t>FOLRα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二等辺三角形 30"/>
            <p:cNvSpPr/>
            <p:nvPr/>
          </p:nvSpPr>
          <p:spPr>
            <a:xfrm>
              <a:off x="4639800" y="2317656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32" name="二等辺三角形 31"/>
            <p:cNvSpPr/>
            <p:nvPr/>
          </p:nvSpPr>
          <p:spPr>
            <a:xfrm>
              <a:off x="3691504" y="305983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33" name="二等辺三角形 32"/>
            <p:cNvSpPr/>
            <p:nvPr/>
          </p:nvSpPr>
          <p:spPr>
            <a:xfrm>
              <a:off x="3918576" y="305983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927880" y="2414048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927880" y="212601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0" name="直線コネクタ 39"/>
            <p:cNvCxnSpPr/>
            <p:nvPr/>
          </p:nvCxnSpPr>
          <p:spPr>
            <a:xfrm>
              <a:off x="3683404" y="856575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/>
            <p:cNvSpPr txBox="1"/>
            <p:nvPr/>
          </p:nvSpPr>
          <p:spPr>
            <a:xfrm>
              <a:off x="3547488" y="642839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coIP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1927880" y="255425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1340768" y="395536"/>
              <a:ext cx="129614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PHB1 (32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1903496" y="125963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1927880" y="169168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63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1927880" y="154766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1927880" y="188216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48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0" name="テキスト ボックス 59"/>
          <p:cNvSpPr txBox="1"/>
          <p:nvPr/>
        </p:nvSpPr>
        <p:spPr>
          <a:xfrm>
            <a:off x="994421" y="1189502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994421" y="2745830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994421" y="41833820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6F1C88A7-558F-48D7-9486-CB492BEFFF3C}"/>
              </a:ext>
            </a:extLst>
          </p:cNvPr>
          <p:cNvSpPr/>
          <p:nvPr/>
        </p:nvSpPr>
        <p:spPr>
          <a:xfrm>
            <a:off x="172764" y="242724"/>
            <a:ext cx="12107802" cy="228280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endParaRPr lang="en-US" altLang="ja-JP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117" b="1" dirty="0">
                <a:latin typeface="Arial" panose="020B0604020202020204" pitchFamily="34" charset="0"/>
                <a:cs typeface="Arial" panose="020B0604020202020204" pitchFamily="34" charset="0"/>
              </a:rPr>
              <a:t>   Supplementary FigureS5</a:t>
            </a:r>
            <a:endParaRPr lang="ja-JP" altLang="en-US" sz="71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994421" y="2025622"/>
            <a:ext cx="6832659" cy="106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326" b="1" dirty="0">
                <a:latin typeface="Arial" pitchFamily="34" charset="0"/>
                <a:cs typeface="Arial" pitchFamily="34" charset="0"/>
              </a:rPr>
              <a:t>Figure 3F</a:t>
            </a:r>
            <a:endParaRPr kumimoji="1" lang="ja-JP" altLang="en-US" sz="6326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" name="グループ化 22"/>
          <p:cNvGrpSpPr/>
          <p:nvPr/>
        </p:nvGrpSpPr>
        <p:grpSpPr>
          <a:xfrm>
            <a:off x="6758604" y="16829720"/>
            <a:ext cx="20048084" cy="13285721"/>
            <a:chOff x="980728" y="323529"/>
            <a:chExt cx="3803088" cy="2520279"/>
          </a:xfrm>
        </p:grpSpPr>
        <p:pic>
          <p:nvPicPr>
            <p:cNvPr id="2050" name="Picture 2" descr="C:\Users\Yuta Onodera\Desktop\siPHB1 PHB1 2020.02.28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988840" y="1187624"/>
              <a:ext cx="2697162" cy="1549400"/>
            </a:xfrm>
            <a:prstGeom prst="rect">
              <a:avLst/>
            </a:prstGeom>
            <a:noFill/>
          </p:spPr>
        </p:pic>
        <p:sp>
          <p:nvSpPr>
            <p:cNvPr id="8" name="テキスト ボックス 7"/>
            <p:cNvSpPr txBox="1"/>
            <p:nvPr/>
          </p:nvSpPr>
          <p:spPr>
            <a:xfrm rot="16200000">
              <a:off x="2764613" y="720980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Control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 rot="16200000">
              <a:off x="2999271" y="711107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siPHB1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二等辺三角形 9"/>
            <p:cNvSpPr/>
            <p:nvPr/>
          </p:nvSpPr>
          <p:spPr>
            <a:xfrm>
              <a:off x="4639800" y="2376328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1" name="二等辺三角形 10"/>
            <p:cNvSpPr/>
            <p:nvPr/>
          </p:nvSpPr>
          <p:spPr>
            <a:xfrm>
              <a:off x="3226312" y="26997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2" name="二等辺三角形 11"/>
            <p:cNvSpPr/>
            <p:nvPr/>
          </p:nvSpPr>
          <p:spPr>
            <a:xfrm>
              <a:off x="3453384" y="26997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401728" y="2427745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401728" y="2115329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980728" y="539552"/>
              <a:ext cx="129614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PHB1 (32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471448" y="98263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401728" y="1390673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401728" y="187147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401728" y="1534689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4" name="グループ化 53"/>
          <p:cNvGrpSpPr/>
          <p:nvPr/>
        </p:nvGrpSpPr>
        <p:grpSpPr>
          <a:xfrm>
            <a:off x="6758605" y="4303175"/>
            <a:ext cx="20257168" cy="11387765"/>
            <a:chOff x="1282096" y="539552"/>
            <a:chExt cx="3842751" cy="2160240"/>
          </a:xfrm>
        </p:grpSpPr>
        <p:sp>
          <p:nvSpPr>
            <p:cNvPr id="33" name="テキスト ボックス 32"/>
            <p:cNvSpPr txBox="1"/>
            <p:nvPr/>
          </p:nvSpPr>
          <p:spPr>
            <a:xfrm>
              <a:off x="1282096" y="539552"/>
              <a:ext cx="18588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MDM2 (</a:t>
              </a:r>
              <a:r>
                <a:rPr lang="en-US" altLang="ja-JP" sz="6326" b="1" dirty="0">
                  <a:latin typeface="Arial" pitchFamily="34" charset="0"/>
                  <a:cs typeface="Arial" pitchFamily="34" charset="0"/>
                </a:rPr>
                <a:t>60-90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2" name="グループ化 51"/>
            <p:cNvGrpSpPr/>
            <p:nvPr/>
          </p:nvGrpSpPr>
          <p:grpSpPr>
            <a:xfrm>
              <a:off x="1678712" y="673696"/>
              <a:ext cx="3446135" cy="2026096"/>
              <a:chOff x="1678712" y="385664"/>
              <a:chExt cx="3446135" cy="2026096"/>
            </a:xfrm>
          </p:grpSpPr>
          <p:sp>
            <p:nvSpPr>
              <p:cNvPr id="26" name="テキスト ボックス 25"/>
              <p:cNvSpPr txBox="1"/>
              <p:nvPr/>
            </p:nvSpPr>
            <p:spPr>
              <a:xfrm rot="16200000">
                <a:off x="3467320" y="783115"/>
                <a:ext cx="1008112" cy="2329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380" b="1" dirty="0">
                    <a:latin typeface="Arial" pitchFamily="34" charset="0"/>
                    <a:cs typeface="Arial" pitchFamily="34" charset="0"/>
                  </a:rPr>
                  <a:t>Control</a:t>
                </a:r>
                <a:endParaRPr kumimoji="1" lang="ja-JP" altLang="en-US" sz="738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 rot="16200000">
                <a:off x="3272061" y="773242"/>
                <a:ext cx="1008112" cy="2329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380" b="1" dirty="0">
                    <a:latin typeface="Arial" pitchFamily="34" charset="0"/>
                    <a:cs typeface="Arial" pitchFamily="34" charset="0"/>
                  </a:rPr>
                  <a:t>siPHB1</a:t>
                </a:r>
                <a:endParaRPr kumimoji="1" lang="ja-JP" altLang="en-US" sz="738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二等辺三角形 28"/>
              <p:cNvSpPr/>
              <p:nvPr/>
            </p:nvSpPr>
            <p:spPr>
              <a:xfrm>
                <a:off x="3705984" y="226774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30" name="二等辺三角形 29"/>
              <p:cNvSpPr/>
              <p:nvPr/>
            </p:nvSpPr>
            <p:spPr>
              <a:xfrm>
                <a:off x="3933056" y="226774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1678712" y="1054641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kumimoji="1" lang="en-US" altLang="ja-JP" sz="6326" b="1" dirty="0" err="1">
                    <a:latin typeface="Arial" pitchFamily="34" charset="0"/>
                    <a:cs typeface="Arial" pitchFamily="34" charset="0"/>
                  </a:rPr>
                  <a:t>KDa</a:t>
                </a:r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)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1703096" y="1614909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100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>
                <a:off x="1703096" y="2008290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50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1703096" y="1748836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75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27" name="Picture 3" descr="C:\Users\Yuta Onodera\Desktop\siFOLR1 MDM2 2020.03.11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276872" y="1312069"/>
                <a:ext cx="2847975" cy="955675"/>
              </a:xfrm>
              <a:prstGeom prst="rect">
                <a:avLst/>
              </a:prstGeom>
              <a:noFill/>
            </p:spPr>
          </p:pic>
          <p:sp>
            <p:nvSpPr>
              <p:cNvPr id="28" name="二等辺三角形 27"/>
              <p:cNvSpPr/>
              <p:nvPr/>
            </p:nvSpPr>
            <p:spPr>
              <a:xfrm>
                <a:off x="4586461" y="1729780"/>
                <a:ext cx="144016" cy="144016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</p:grpSp>
      </p:grpSp>
      <p:grpSp>
        <p:nvGrpSpPr>
          <p:cNvPr id="53" name="グループ化 52"/>
          <p:cNvGrpSpPr/>
          <p:nvPr/>
        </p:nvGrpSpPr>
        <p:grpSpPr>
          <a:xfrm>
            <a:off x="6752574" y="34670550"/>
            <a:ext cx="21170793" cy="9869397"/>
            <a:chOff x="1280952" y="6300192"/>
            <a:chExt cx="4016064" cy="1872208"/>
          </a:xfrm>
        </p:grpSpPr>
        <p:sp>
          <p:nvSpPr>
            <p:cNvPr id="40" name="テキスト ボックス 39"/>
            <p:cNvSpPr txBox="1"/>
            <p:nvPr/>
          </p:nvSpPr>
          <p:spPr>
            <a:xfrm rot="16200000">
              <a:off x="3284036" y="6769652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Control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 rot="16200000">
              <a:off x="3082008" y="6759779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siPHB1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二等辺三角形 42"/>
            <p:cNvSpPr/>
            <p:nvPr/>
          </p:nvSpPr>
          <p:spPr>
            <a:xfrm>
              <a:off x="3513836" y="8028384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4" name="二等辺三角形 43"/>
            <p:cNvSpPr/>
            <p:nvPr/>
          </p:nvSpPr>
          <p:spPr>
            <a:xfrm>
              <a:off x="3740908" y="8028384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1280952" y="6300192"/>
              <a:ext cx="207604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GAPDH (36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1916832" y="717532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8" name="Picture 4" descr="H:\WB\2020\2月\20200229\siPHB1 GAPDH 2020.02.29_12.09.12-01_Ch\siPHB1 GAPDH 2020.02.29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492896" y="7380312"/>
              <a:ext cx="2738438" cy="646112"/>
            </a:xfrm>
            <a:prstGeom prst="rect">
              <a:avLst/>
            </a:prstGeom>
            <a:noFill/>
          </p:spPr>
        </p:pic>
        <p:sp>
          <p:nvSpPr>
            <p:cNvPr id="42" name="二等辺三角形 41"/>
            <p:cNvSpPr/>
            <p:nvPr/>
          </p:nvSpPr>
          <p:spPr>
            <a:xfrm>
              <a:off x="5153000" y="7636594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1916832" y="753536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5" name="テキスト ボックス 54"/>
          <p:cNvSpPr txBox="1"/>
          <p:nvPr/>
        </p:nvSpPr>
        <p:spPr>
          <a:xfrm>
            <a:off x="994421" y="10756245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994421" y="24801155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994421" y="40695044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グループ化 48"/>
          <p:cNvGrpSpPr/>
          <p:nvPr/>
        </p:nvGrpSpPr>
        <p:grpSpPr>
          <a:xfrm>
            <a:off x="6758605" y="16829717"/>
            <a:ext cx="19294930" cy="13285721"/>
            <a:chOff x="1282096" y="2915816"/>
            <a:chExt cx="3660216" cy="2520279"/>
          </a:xfrm>
        </p:grpSpPr>
        <p:pic>
          <p:nvPicPr>
            <p:cNvPr id="43" name="Picture 2" descr="C:\Users\Yuta Onodera\Desktop\2020.02.27 siPHB2 PHB2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300112" y="3622560"/>
              <a:ext cx="2571750" cy="1627188"/>
            </a:xfrm>
            <a:prstGeom prst="rect">
              <a:avLst/>
            </a:prstGeom>
            <a:noFill/>
          </p:spPr>
        </p:pic>
        <p:sp>
          <p:nvSpPr>
            <p:cNvPr id="6" name="テキスト ボックス 5"/>
            <p:cNvSpPr txBox="1"/>
            <p:nvPr/>
          </p:nvSpPr>
          <p:spPr>
            <a:xfrm rot="16200000">
              <a:off x="3382973" y="3313267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Control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 rot="16200000">
              <a:off x="3617631" y="3303394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siPHB2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二等辺三角形 7"/>
            <p:cNvSpPr/>
            <p:nvPr/>
          </p:nvSpPr>
          <p:spPr>
            <a:xfrm>
              <a:off x="4798296" y="4907656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9" name="二等辺三角形 8"/>
            <p:cNvSpPr/>
            <p:nvPr/>
          </p:nvSpPr>
          <p:spPr>
            <a:xfrm>
              <a:off x="3863336" y="5292079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0" name="二等辺三角形 9"/>
            <p:cNvSpPr/>
            <p:nvPr/>
          </p:nvSpPr>
          <p:spPr>
            <a:xfrm>
              <a:off x="4090408" y="5292079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703096" y="502003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703096" y="461008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282096" y="2915816"/>
              <a:ext cx="129614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PHB2 (35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700808" y="341987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703096" y="370254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703096" y="428088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703096" y="387094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" name="グループ化 47"/>
          <p:cNvGrpSpPr/>
          <p:nvPr/>
        </p:nvGrpSpPr>
        <p:grpSpPr>
          <a:xfrm>
            <a:off x="6758605" y="3923583"/>
            <a:ext cx="20620487" cy="11574546"/>
            <a:chOff x="1282096" y="467544"/>
            <a:chExt cx="3911672" cy="2195672"/>
          </a:xfrm>
        </p:grpSpPr>
        <p:pic>
          <p:nvPicPr>
            <p:cNvPr id="2050" name="Picture 2" descr="H:\WB\2019\11月\20191130\MDM2 2019.11.30_12.07.52-03_Ch\MDM2 2019.11.30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332038" y="1430338"/>
              <a:ext cx="2725737" cy="1065212"/>
            </a:xfrm>
            <a:prstGeom prst="rect">
              <a:avLst/>
            </a:prstGeom>
            <a:noFill/>
          </p:spPr>
        </p:pic>
        <p:sp>
          <p:nvSpPr>
            <p:cNvPr id="19" name="テキスト ボックス 18"/>
            <p:cNvSpPr txBox="1"/>
            <p:nvPr/>
          </p:nvSpPr>
          <p:spPr>
            <a:xfrm rot="16200000">
              <a:off x="2838425" y="879507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Control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 rot="16200000">
              <a:off x="2622401" y="855122"/>
              <a:ext cx="1008112" cy="2329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380" b="1" dirty="0">
                  <a:latin typeface="Arial" pitchFamily="34" charset="0"/>
                  <a:cs typeface="Arial" pitchFamily="34" charset="0"/>
                </a:rPr>
                <a:t>siPHB2</a:t>
              </a:r>
              <a:endParaRPr kumimoji="1" lang="ja-JP" altLang="en-US" sz="738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二等辺三角形 20"/>
            <p:cNvSpPr/>
            <p:nvPr/>
          </p:nvSpPr>
          <p:spPr>
            <a:xfrm>
              <a:off x="5049752" y="1667296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2" name="二等辺三角形 21"/>
            <p:cNvSpPr/>
            <p:nvPr/>
          </p:nvSpPr>
          <p:spPr>
            <a:xfrm>
              <a:off x="3032384" y="2519200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3" name="二等辺三角形 22"/>
            <p:cNvSpPr/>
            <p:nvPr/>
          </p:nvSpPr>
          <p:spPr>
            <a:xfrm>
              <a:off x="3259456" y="2519200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282096" y="539552"/>
              <a:ext cx="214690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MDM2 (</a:t>
              </a:r>
              <a:r>
                <a:rPr lang="en-US" altLang="ja-JP" sz="6326" b="1" dirty="0">
                  <a:latin typeface="Arial" pitchFamily="34" charset="0"/>
                  <a:cs typeface="Arial" pitchFamily="34" charset="0"/>
                </a:rPr>
                <a:t>60-90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00808" y="1126649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703096" y="1390673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703096" y="213476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703096" y="159643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0" name="グループ化 49"/>
          <p:cNvGrpSpPr/>
          <p:nvPr/>
        </p:nvGrpSpPr>
        <p:grpSpPr>
          <a:xfrm>
            <a:off x="6752574" y="34670550"/>
            <a:ext cx="20110214" cy="10248989"/>
            <a:chOff x="1280952" y="6300192"/>
            <a:chExt cx="3814874" cy="1944216"/>
          </a:xfrm>
        </p:grpSpPr>
        <p:sp>
          <p:nvSpPr>
            <p:cNvPr id="38" name="テキスト ボックス 37"/>
            <p:cNvSpPr txBox="1"/>
            <p:nvPr/>
          </p:nvSpPr>
          <p:spPr>
            <a:xfrm>
              <a:off x="1280952" y="6300192"/>
              <a:ext cx="207604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GAPDH (36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6" name="グループ化 45"/>
            <p:cNvGrpSpPr/>
            <p:nvPr/>
          </p:nvGrpSpPr>
          <p:grpSpPr>
            <a:xfrm>
              <a:off x="1844824" y="6591052"/>
              <a:ext cx="3251002" cy="1653356"/>
              <a:chOff x="1844824" y="6375028"/>
              <a:chExt cx="3251002" cy="1653356"/>
            </a:xfrm>
          </p:grpSpPr>
          <p:pic>
            <p:nvPicPr>
              <p:cNvPr id="2051" name="Picture 3" descr="H:\WB\2020\2月\20200228\siPHB2 Gapdh 2020.02.28_12.48.17-01_Ch\Gapdh 2020.02.28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2420888" y="7308304"/>
                <a:ext cx="2674938" cy="593725"/>
              </a:xfrm>
              <a:prstGeom prst="rect">
                <a:avLst/>
              </a:prstGeom>
              <a:noFill/>
            </p:spPr>
          </p:pic>
          <p:sp>
            <p:nvSpPr>
              <p:cNvPr id="31" name="テキスト ボックス 30"/>
              <p:cNvSpPr txBox="1"/>
              <p:nvPr/>
            </p:nvSpPr>
            <p:spPr>
              <a:xfrm rot="16200000">
                <a:off x="2659485" y="6772479"/>
                <a:ext cx="1008112" cy="2329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380" b="1" dirty="0">
                    <a:latin typeface="Arial" pitchFamily="34" charset="0"/>
                    <a:cs typeface="Arial" pitchFamily="34" charset="0"/>
                  </a:rPr>
                  <a:t>Control</a:t>
                </a:r>
                <a:endParaRPr kumimoji="1" lang="ja-JP" altLang="en-US" sz="738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 rot="16200000">
                <a:off x="2894143" y="6762606"/>
                <a:ext cx="1008112" cy="2329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380" b="1" dirty="0">
                    <a:latin typeface="Arial" pitchFamily="34" charset="0"/>
                    <a:cs typeface="Arial" pitchFamily="34" charset="0"/>
                  </a:rPr>
                  <a:t>siPHB2</a:t>
                </a:r>
                <a:endParaRPr kumimoji="1" lang="ja-JP" altLang="en-US" sz="738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二等辺三角形 32"/>
              <p:cNvSpPr/>
              <p:nvPr/>
            </p:nvSpPr>
            <p:spPr>
              <a:xfrm>
                <a:off x="4869160" y="7549728"/>
                <a:ext cx="144016" cy="144016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34" name="二等辺三角形 33"/>
              <p:cNvSpPr/>
              <p:nvPr/>
            </p:nvSpPr>
            <p:spPr>
              <a:xfrm>
                <a:off x="3091820" y="7884368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35" name="二等辺三角形 34"/>
              <p:cNvSpPr/>
              <p:nvPr/>
            </p:nvSpPr>
            <p:spPr>
              <a:xfrm>
                <a:off x="3318892" y="7884368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1844824" y="7405712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37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>
                <a:off x="1844824" y="7031305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kumimoji="1" lang="en-US" altLang="ja-JP" sz="6326" b="1" dirty="0" err="1">
                    <a:latin typeface="Arial" pitchFamily="34" charset="0"/>
                    <a:cs typeface="Arial" pitchFamily="34" charset="0"/>
                  </a:rPr>
                  <a:t>KDa</a:t>
                </a:r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)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47" name="テキスト ボックス 46"/>
          <p:cNvSpPr txBox="1"/>
          <p:nvPr/>
        </p:nvSpPr>
        <p:spPr>
          <a:xfrm>
            <a:off x="994421" y="2025622"/>
            <a:ext cx="6832659" cy="106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326" b="1" dirty="0">
                <a:latin typeface="Arial" pitchFamily="34" charset="0"/>
                <a:cs typeface="Arial" pitchFamily="34" charset="0"/>
              </a:rPr>
              <a:t>Figure 3F</a:t>
            </a:r>
            <a:endParaRPr kumimoji="1" lang="ja-JP" altLang="en-US" sz="63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994421" y="999706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994421" y="2404197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994421" y="41833820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994421" y="2025622"/>
            <a:ext cx="6832659" cy="106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326" b="1" dirty="0">
                <a:latin typeface="Arial" pitchFamily="34" charset="0"/>
                <a:cs typeface="Arial" pitchFamily="34" charset="0"/>
              </a:rPr>
              <a:t>Figure 3G</a:t>
            </a:r>
            <a:endParaRPr kumimoji="1" lang="ja-JP" altLang="en-US" sz="6326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2" name="グループ化 111"/>
          <p:cNvGrpSpPr/>
          <p:nvPr/>
        </p:nvGrpSpPr>
        <p:grpSpPr>
          <a:xfrm>
            <a:off x="6758607" y="4303175"/>
            <a:ext cx="17340728" cy="14234511"/>
            <a:chOff x="1282096" y="539552"/>
            <a:chExt cx="3289507" cy="2700263"/>
          </a:xfrm>
        </p:grpSpPr>
        <p:pic>
          <p:nvPicPr>
            <p:cNvPr id="70" name="Picture 2" descr="H:\WB\2020\2月\20200201\siFOLR1 CST MDM2 2 2020.02.01_11.20.42-06_Ch\siFOLR1 CST MDM2 2 2020.02.01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636912" y="1331640"/>
              <a:ext cx="1779588" cy="1908175"/>
            </a:xfrm>
            <a:prstGeom prst="rect">
              <a:avLst/>
            </a:prstGeom>
            <a:noFill/>
          </p:spPr>
        </p:pic>
        <p:sp>
          <p:nvSpPr>
            <p:cNvPr id="20" name="テキスト ボックス 19"/>
            <p:cNvSpPr txBox="1"/>
            <p:nvPr/>
          </p:nvSpPr>
          <p:spPr>
            <a:xfrm>
              <a:off x="1282096" y="539552"/>
              <a:ext cx="18588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MDM2 (</a:t>
              </a:r>
              <a:r>
                <a:rPr lang="en-US" altLang="ja-JP" sz="6326" b="1" dirty="0">
                  <a:latin typeface="Arial" pitchFamily="34" charset="0"/>
                  <a:cs typeface="Arial" pitchFamily="34" charset="0"/>
                </a:rPr>
                <a:t>60-90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二等辺三角形 23"/>
            <p:cNvSpPr/>
            <p:nvPr/>
          </p:nvSpPr>
          <p:spPr>
            <a:xfrm>
              <a:off x="3006477" y="255577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5" name="二等辺三角形 24"/>
            <p:cNvSpPr/>
            <p:nvPr/>
          </p:nvSpPr>
          <p:spPr>
            <a:xfrm>
              <a:off x="3233549" y="255577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678712" y="1342673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03096" y="190294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703096" y="2296322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703096" y="2036868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二等辺三角形 30"/>
            <p:cNvSpPr/>
            <p:nvPr/>
          </p:nvSpPr>
          <p:spPr>
            <a:xfrm>
              <a:off x="4427587" y="1748830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grpSp>
          <p:nvGrpSpPr>
            <p:cNvPr id="71" name="グループ化 70"/>
            <p:cNvGrpSpPr/>
            <p:nvPr/>
          </p:nvGrpSpPr>
          <p:grpSpPr>
            <a:xfrm>
              <a:off x="1750195" y="873979"/>
              <a:ext cx="2182861" cy="382843"/>
              <a:chOff x="1750195" y="873979"/>
              <a:chExt cx="2182861" cy="382843"/>
            </a:xfrm>
          </p:grpSpPr>
          <p:sp>
            <p:nvSpPr>
              <p:cNvPr id="59" name="テキスト ボックス 58"/>
              <p:cNvSpPr txBox="1"/>
              <p:nvPr/>
            </p:nvSpPr>
            <p:spPr>
              <a:xfrm>
                <a:off x="1750195" y="1054641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 err="1">
                    <a:latin typeface="Arial" pitchFamily="34" charset="0"/>
                    <a:cs typeface="Arial" pitchFamily="34" charset="0"/>
                  </a:rPr>
                  <a:t>siFOLRα</a:t>
                </a:r>
                <a:endParaRPr kumimoji="1" lang="en-US" altLang="ja-JP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1750195" y="873979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MG132</a:t>
                </a: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283031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>
                <a:off x="3049910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329137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>
                <a:off x="3501008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283031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3049910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>
                <a:off x="3501008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>
                <a:off x="329137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sp>
          <p:nvSpPr>
            <p:cNvPr id="72" name="二等辺三角形 71"/>
            <p:cNvSpPr/>
            <p:nvPr/>
          </p:nvSpPr>
          <p:spPr>
            <a:xfrm>
              <a:off x="3446527" y="255577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73" name="二等辺三角形 72"/>
            <p:cNvSpPr/>
            <p:nvPr/>
          </p:nvSpPr>
          <p:spPr>
            <a:xfrm>
              <a:off x="3673599" y="255577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</p:grpSp>
      <p:grpSp>
        <p:nvGrpSpPr>
          <p:cNvPr id="108" name="グループ化 107"/>
          <p:cNvGrpSpPr/>
          <p:nvPr/>
        </p:nvGrpSpPr>
        <p:grpSpPr>
          <a:xfrm>
            <a:off x="6758608" y="21005232"/>
            <a:ext cx="22012471" cy="10362907"/>
            <a:chOff x="1282096" y="2926849"/>
            <a:chExt cx="4175729" cy="1965826"/>
          </a:xfrm>
        </p:grpSpPr>
        <p:pic>
          <p:nvPicPr>
            <p:cNvPr id="4099" name="Picture 3" descr="C:\Users\Yuta Onodera\Desktop\2020.03.13 MKN1 siFOLR1 MG132 FOLR1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486025" y="3717925"/>
              <a:ext cx="2971800" cy="1174750"/>
            </a:xfrm>
            <a:prstGeom prst="rect">
              <a:avLst/>
            </a:prstGeom>
            <a:noFill/>
          </p:spPr>
        </p:pic>
        <p:sp>
          <p:nvSpPr>
            <p:cNvPr id="9" name="二等辺三角形 8"/>
            <p:cNvSpPr/>
            <p:nvPr/>
          </p:nvSpPr>
          <p:spPr>
            <a:xfrm>
              <a:off x="5013176" y="4427984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954932" y="4409318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282096" y="2926849"/>
              <a:ext cx="200288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FOLRα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 (44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772816" y="357492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954932" y="3751337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954932" y="4165463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5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954932" y="3895353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2873748" y="3600534"/>
              <a:ext cx="106742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siFOLRα</a:t>
              </a:r>
              <a:endParaRPr kumimoji="1" lang="en-US" altLang="ja-JP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2873748" y="3419872"/>
              <a:ext cx="106742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MG132</a:t>
              </a: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3953868" y="3600534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4117772" y="3600534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4281676" y="3600534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4445579" y="3600534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3953868" y="3419872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4117772" y="3419872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4445579" y="3419872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4281676" y="3419872"/>
              <a:ext cx="432048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7" name="二等辺三角形 86"/>
            <p:cNvSpPr/>
            <p:nvPr/>
          </p:nvSpPr>
          <p:spPr>
            <a:xfrm>
              <a:off x="4139555" y="466305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88" name="二等辺三角形 87"/>
            <p:cNvSpPr/>
            <p:nvPr/>
          </p:nvSpPr>
          <p:spPr>
            <a:xfrm>
              <a:off x="4301604" y="466305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89" name="二等辺三角形 88"/>
            <p:cNvSpPr/>
            <p:nvPr/>
          </p:nvSpPr>
          <p:spPr>
            <a:xfrm>
              <a:off x="4463653" y="466305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90" name="二等辺三角形 89"/>
            <p:cNvSpPr/>
            <p:nvPr/>
          </p:nvSpPr>
          <p:spPr>
            <a:xfrm>
              <a:off x="4625702" y="466305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</p:grpSp>
      <p:grpSp>
        <p:nvGrpSpPr>
          <p:cNvPr id="107" name="グループ化 106"/>
          <p:cNvGrpSpPr/>
          <p:nvPr/>
        </p:nvGrpSpPr>
        <p:grpSpPr>
          <a:xfrm>
            <a:off x="6752574" y="34670551"/>
            <a:ext cx="21259713" cy="10248989"/>
            <a:chOff x="1280952" y="6300192"/>
            <a:chExt cx="4032932" cy="1944216"/>
          </a:xfrm>
        </p:grpSpPr>
        <p:pic>
          <p:nvPicPr>
            <p:cNvPr id="4100" name="Picture 4" descr="H:\WB\2020\3月\20200311\siFOLR1 GAPDH 2020.03.11_12.57.57-01_Ch\siFOLR1 GAPDH 2020.03.11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492896" y="7380312"/>
              <a:ext cx="2820988" cy="849312"/>
            </a:xfrm>
            <a:prstGeom prst="rect">
              <a:avLst/>
            </a:prstGeom>
            <a:noFill/>
          </p:spPr>
        </p:pic>
        <p:sp>
          <p:nvSpPr>
            <p:cNvPr id="37" name="テキスト ボックス 36"/>
            <p:cNvSpPr txBox="1"/>
            <p:nvPr/>
          </p:nvSpPr>
          <p:spPr>
            <a:xfrm>
              <a:off x="1280952" y="6300192"/>
              <a:ext cx="207604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GAPDH (36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1916832" y="717532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二等辺三角形 39"/>
            <p:cNvSpPr/>
            <p:nvPr/>
          </p:nvSpPr>
          <p:spPr>
            <a:xfrm>
              <a:off x="5153000" y="7636594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1916832" y="753536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二等辺三角形 91"/>
            <p:cNvSpPr/>
            <p:nvPr/>
          </p:nvSpPr>
          <p:spPr>
            <a:xfrm>
              <a:off x="3717032" y="81003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93" name="二等辺三角形 92"/>
            <p:cNvSpPr/>
            <p:nvPr/>
          </p:nvSpPr>
          <p:spPr>
            <a:xfrm>
              <a:off x="3933056" y="81003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94" name="二等辺三角形 93"/>
            <p:cNvSpPr/>
            <p:nvPr/>
          </p:nvSpPr>
          <p:spPr>
            <a:xfrm>
              <a:off x="4149080" y="81003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95" name="二等辺三角形 94"/>
            <p:cNvSpPr/>
            <p:nvPr/>
          </p:nvSpPr>
          <p:spPr>
            <a:xfrm>
              <a:off x="4365104" y="8100392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grpSp>
          <p:nvGrpSpPr>
            <p:cNvPr id="96" name="グループ化 95"/>
            <p:cNvGrpSpPr/>
            <p:nvPr/>
          </p:nvGrpSpPr>
          <p:grpSpPr>
            <a:xfrm>
              <a:off x="2460750" y="7138675"/>
              <a:ext cx="2182861" cy="382843"/>
              <a:chOff x="1750195" y="873979"/>
              <a:chExt cx="2182861" cy="382843"/>
            </a:xfrm>
          </p:grpSpPr>
          <p:sp>
            <p:nvSpPr>
              <p:cNvPr id="97" name="テキスト ボックス 96"/>
              <p:cNvSpPr txBox="1"/>
              <p:nvPr/>
            </p:nvSpPr>
            <p:spPr>
              <a:xfrm>
                <a:off x="1750195" y="1054641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 err="1">
                    <a:latin typeface="Arial" pitchFamily="34" charset="0"/>
                    <a:cs typeface="Arial" pitchFamily="34" charset="0"/>
                  </a:rPr>
                  <a:t>siFOLRα</a:t>
                </a:r>
                <a:endParaRPr kumimoji="1" lang="en-US" altLang="ja-JP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>
              <a:xfrm>
                <a:off x="1750195" y="873979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MG132</a:t>
                </a:r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>
                <a:off x="283031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0" name="テキスト ボックス 99"/>
              <p:cNvSpPr txBox="1"/>
              <p:nvPr/>
            </p:nvSpPr>
            <p:spPr>
              <a:xfrm>
                <a:off x="3049910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1" name="テキスト ボックス 100"/>
              <p:cNvSpPr txBox="1"/>
              <p:nvPr/>
            </p:nvSpPr>
            <p:spPr>
              <a:xfrm>
                <a:off x="329137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>
                <a:off x="3501008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3" name="テキスト ボックス 102"/>
              <p:cNvSpPr txBox="1"/>
              <p:nvPr/>
            </p:nvSpPr>
            <p:spPr>
              <a:xfrm>
                <a:off x="283031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4" name="テキスト ボックス 103"/>
              <p:cNvSpPr txBox="1"/>
              <p:nvPr/>
            </p:nvSpPr>
            <p:spPr>
              <a:xfrm>
                <a:off x="3049910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5" name="テキスト ボックス 104"/>
              <p:cNvSpPr txBox="1"/>
              <p:nvPr/>
            </p:nvSpPr>
            <p:spPr>
              <a:xfrm>
                <a:off x="3501008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6" name="テキスト ボックス 105"/>
              <p:cNvSpPr txBox="1"/>
              <p:nvPr/>
            </p:nvSpPr>
            <p:spPr>
              <a:xfrm>
                <a:off x="329137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</p:grpSp>
      <p:sp>
        <p:nvSpPr>
          <p:cNvPr id="110" name="テキスト ボックス 109"/>
          <p:cNvSpPr txBox="1"/>
          <p:nvPr/>
        </p:nvSpPr>
        <p:spPr>
          <a:xfrm>
            <a:off x="994421" y="1189502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994421" y="27458301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994421" y="41833820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994421" y="2025622"/>
            <a:ext cx="6832659" cy="1065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326" b="1" dirty="0">
                <a:latin typeface="Arial" pitchFamily="34" charset="0"/>
                <a:cs typeface="Arial" pitchFamily="34" charset="0"/>
              </a:rPr>
              <a:t>Figure 3G</a:t>
            </a:r>
            <a:endParaRPr kumimoji="1" lang="ja-JP" altLang="en-US" sz="6326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9" name="グループ化 118"/>
          <p:cNvGrpSpPr/>
          <p:nvPr/>
        </p:nvGrpSpPr>
        <p:grpSpPr>
          <a:xfrm>
            <a:off x="6752574" y="29076930"/>
            <a:ext cx="21075600" cy="9769132"/>
            <a:chOff x="1280952" y="6671265"/>
            <a:chExt cx="3998006" cy="1853188"/>
          </a:xfrm>
        </p:grpSpPr>
        <p:sp>
          <p:nvSpPr>
            <p:cNvPr id="12" name="テキスト ボックス 11"/>
            <p:cNvSpPr txBox="1"/>
            <p:nvPr/>
          </p:nvSpPr>
          <p:spPr>
            <a:xfrm>
              <a:off x="1844824" y="7984951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2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1280952" y="6671265"/>
              <a:ext cx="2076040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GAPDH (36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1844824" y="7621736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37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1854349" y="741992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084" name="Picture 12" descr="C:\Users\Yuta Onodera\Desktop\siPHB2 GAPDH 2020.03.11_13.01.46-06_Ch+Marker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492896" y="7524328"/>
              <a:ext cx="2786062" cy="1000125"/>
            </a:xfrm>
            <a:prstGeom prst="rect">
              <a:avLst/>
            </a:prstGeom>
            <a:noFill/>
          </p:spPr>
        </p:pic>
        <p:sp>
          <p:nvSpPr>
            <p:cNvPr id="37" name="二等辺三角形 36"/>
            <p:cNvSpPr/>
            <p:nvPr/>
          </p:nvSpPr>
          <p:spPr>
            <a:xfrm>
              <a:off x="5013176" y="7740352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grpSp>
          <p:nvGrpSpPr>
            <p:cNvPr id="75" name="グループ化 74"/>
            <p:cNvGrpSpPr/>
            <p:nvPr/>
          </p:nvGrpSpPr>
          <p:grpSpPr>
            <a:xfrm>
              <a:off x="1572271" y="7061334"/>
              <a:ext cx="2182861" cy="382843"/>
              <a:chOff x="1750195" y="873979"/>
              <a:chExt cx="2182861" cy="382843"/>
            </a:xfrm>
          </p:grpSpPr>
          <p:sp>
            <p:nvSpPr>
              <p:cNvPr id="76" name="テキスト ボックス 75"/>
              <p:cNvSpPr txBox="1"/>
              <p:nvPr/>
            </p:nvSpPr>
            <p:spPr>
              <a:xfrm>
                <a:off x="1750195" y="1054641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siPHB2</a:t>
                </a: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1750195" y="873979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MG132</a:t>
                </a:r>
              </a:p>
            </p:txBody>
          </p:sp>
          <p:sp>
            <p:nvSpPr>
              <p:cNvPr id="78" name="テキスト ボックス 77"/>
              <p:cNvSpPr txBox="1"/>
              <p:nvPr/>
            </p:nvSpPr>
            <p:spPr>
              <a:xfrm>
                <a:off x="283031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79" name="テキスト ボックス 78"/>
              <p:cNvSpPr txBox="1"/>
              <p:nvPr/>
            </p:nvSpPr>
            <p:spPr>
              <a:xfrm>
                <a:off x="3049910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80" name="テキスト ボックス 79"/>
              <p:cNvSpPr txBox="1"/>
              <p:nvPr/>
            </p:nvSpPr>
            <p:spPr>
              <a:xfrm>
                <a:off x="3291375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81" name="テキスト ボックス 80"/>
              <p:cNvSpPr txBox="1"/>
              <p:nvPr/>
            </p:nvSpPr>
            <p:spPr>
              <a:xfrm>
                <a:off x="3501008" y="105464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>
                <a:off x="283031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>
                <a:off x="3049910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>
                <a:off x="3501008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>
                <a:off x="3291375" y="873979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sp>
          <p:nvSpPr>
            <p:cNvPr id="86" name="二等辺三角形 85"/>
            <p:cNvSpPr/>
            <p:nvPr/>
          </p:nvSpPr>
          <p:spPr>
            <a:xfrm>
              <a:off x="2833886" y="824440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87" name="二等辺三角形 86"/>
            <p:cNvSpPr/>
            <p:nvPr/>
          </p:nvSpPr>
          <p:spPr>
            <a:xfrm>
              <a:off x="3060958" y="824440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88" name="二等辺三角形 87"/>
            <p:cNvSpPr/>
            <p:nvPr/>
          </p:nvSpPr>
          <p:spPr>
            <a:xfrm>
              <a:off x="3273936" y="824440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89" name="二等辺三角形 88"/>
            <p:cNvSpPr/>
            <p:nvPr/>
          </p:nvSpPr>
          <p:spPr>
            <a:xfrm>
              <a:off x="3501008" y="8244408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</p:grpSp>
      <p:grpSp>
        <p:nvGrpSpPr>
          <p:cNvPr id="181" name="グループ化 180"/>
          <p:cNvGrpSpPr/>
          <p:nvPr/>
        </p:nvGrpSpPr>
        <p:grpSpPr>
          <a:xfrm>
            <a:off x="6758605" y="15353453"/>
            <a:ext cx="21186861" cy="9869397"/>
            <a:chOff x="1282096" y="4067944"/>
            <a:chExt cx="4019112" cy="1872208"/>
          </a:xfrm>
        </p:grpSpPr>
        <p:sp>
          <p:nvSpPr>
            <p:cNvPr id="14" name="テキスト ボックス 13"/>
            <p:cNvSpPr txBox="1"/>
            <p:nvPr/>
          </p:nvSpPr>
          <p:spPr>
            <a:xfrm>
              <a:off x="1282096" y="4067944"/>
              <a:ext cx="129614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PHB2 (35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2" name="グループ化 121"/>
            <p:cNvGrpSpPr/>
            <p:nvPr/>
          </p:nvGrpSpPr>
          <p:grpSpPr>
            <a:xfrm>
              <a:off x="1844824" y="4482887"/>
              <a:ext cx="3456384" cy="1457265"/>
              <a:chOff x="2276872" y="3178235"/>
              <a:chExt cx="3456384" cy="1457265"/>
            </a:xfrm>
          </p:grpSpPr>
          <p:sp>
            <p:nvSpPr>
              <p:cNvPr id="15" name="テキスト ボックス 14"/>
              <p:cNvSpPr txBox="1"/>
              <p:nvPr/>
            </p:nvSpPr>
            <p:spPr>
              <a:xfrm>
                <a:off x="2276872" y="3419872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kumimoji="1" lang="en-US" altLang="ja-JP" sz="6326" b="1" dirty="0" err="1">
                    <a:latin typeface="Arial" pitchFamily="34" charset="0"/>
                    <a:cs typeface="Arial" pitchFamily="34" charset="0"/>
                  </a:rPr>
                  <a:t>KDa</a:t>
                </a:r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)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3086" name="Picture 14" descr="H:\WB\2020\3月\20200310\PHB2 2020.03.10_12.09.28-02_Ch\PHB2 2020.03.10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887663" y="3557588"/>
                <a:ext cx="2778125" cy="1077912"/>
              </a:xfrm>
              <a:prstGeom prst="rect">
                <a:avLst/>
              </a:prstGeom>
              <a:noFill/>
            </p:spPr>
          </p:pic>
          <p:sp>
            <p:nvSpPr>
              <p:cNvPr id="93" name="二等辺三角形 92"/>
              <p:cNvSpPr/>
              <p:nvPr/>
            </p:nvSpPr>
            <p:spPr>
              <a:xfrm>
                <a:off x="4082406" y="448018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94" name="二等辺三角形 93"/>
              <p:cNvSpPr/>
              <p:nvPr/>
            </p:nvSpPr>
            <p:spPr>
              <a:xfrm>
                <a:off x="4309478" y="448018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95" name="二等辺三角形 94"/>
              <p:cNvSpPr/>
              <p:nvPr/>
            </p:nvSpPr>
            <p:spPr>
              <a:xfrm>
                <a:off x="4522456" y="448018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96" name="二等辺三角形 95"/>
              <p:cNvSpPr/>
              <p:nvPr/>
            </p:nvSpPr>
            <p:spPr>
              <a:xfrm>
                <a:off x="4749528" y="4480184"/>
                <a:ext cx="144016" cy="144016"/>
              </a:xfrm>
              <a:prstGeom prst="triangle">
                <a:avLst/>
              </a:prstGeom>
              <a:solidFill>
                <a:srgbClr val="00B050"/>
              </a:solidFill>
              <a:ln>
                <a:noFill/>
              </a:ln>
              <a:scene3d>
                <a:camera prst="orthographicFront">
                  <a:rot lat="0" lon="0" rev="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grpSp>
            <p:nvGrpSpPr>
              <p:cNvPr id="97" name="グループ化 96"/>
              <p:cNvGrpSpPr/>
              <p:nvPr/>
            </p:nvGrpSpPr>
            <p:grpSpPr>
              <a:xfrm>
                <a:off x="2830315" y="3178235"/>
                <a:ext cx="2182861" cy="382843"/>
                <a:chOff x="1750195" y="873979"/>
                <a:chExt cx="2182861" cy="382843"/>
              </a:xfrm>
            </p:grpSpPr>
            <p:sp>
              <p:nvSpPr>
                <p:cNvPr id="98" name="テキスト ボックス 97"/>
                <p:cNvSpPr txBox="1"/>
                <p:nvPr/>
              </p:nvSpPr>
              <p:spPr>
                <a:xfrm>
                  <a:off x="1750195" y="1054641"/>
                  <a:ext cx="1067420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siPHB2</a:t>
                  </a:r>
                </a:p>
              </p:txBody>
            </p:sp>
            <p:sp>
              <p:nvSpPr>
                <p:cNvPr id="99" name="テキスト ボックス 98"/>
                <p:cNvSpPr txBox="1"/>
                <p:nvPr/>
              </p:nvSpPr>
              <p:spPr>
                <a:xfrm>
                  <a:off x="1750195" y="873979"/>
                  <a:ext cx="1067420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MG132</a:t>
                  </a:r>
                </a:p>
              </p:txBody>
            </p:sp>
            <p:sp>
              <p:nvSpPr>
                <p:cNvPr id="100" name="テキスト ボックス 99"/>
                <p:cNvSpPr txBox="1"/>
                <p:nvPr/>
              </p:nvSpPr>
              <p:spPr>
                <a:xfrm>
                  <a:off x="2830315" y="1054641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3049910" y="1054641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102" name="テキスト ボックス 101"/>
                <p:cNvSpPr txBox="1"/>
                <p:nvPr/>
              </p:nvSpPr>
              <p:spPr>
                <a:xfrm>
                  <a:off x="3291375" y="1054641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+</a:t>
                  </a:r>
                </a:p>
              </p:txBody>
            </p:sp>
            <p:sp>
              <p:nvSpPr>
                <p:cNvPr id="103" name="テキスト ボックス 102"/>
                <p:cNvSpPr txBox="1"/>
                <p:nvPr/>
              </p:nvSpPr>
              <p:spPr>
                <a:xfrm>
                  <a:off x="3501008" y="1054641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+</a:t>
                  </a:r>
                </a:p>
              </p:txBody>
            </p:sp>
            <p:sp>
              <p:nvSpPr>
                <p:cNvPr id="104" name="テキスト ボックス 103"/>
                <p:cNvSpPr txBox="1"/>
                <p:nvPr/>
              </p:nvSpPr>
              <p:spPr>
                <a:xfrm>
                  <a:off x="2830315" y="873979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  <p:sp>
              <p:nvSpPr>
                <p:cNvPr id="105" name="テキスト ボックス 104"/>
                <p:cNvSpPr txBox="1"/>
                <p:nvPr/>
              </p:nvSpPr>
              <p:spPr>
                <a:xfrm>
                  <a:off x="3049910" y="873979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+</a:t>
                  </a:r>
                </a:p>
              </p:txBody>
            </p:sp>
            <p:sp>
              <p:nvSpPr>
                <p:cNvPr id="106" name="テキスト ボックス 105"/>
                <p:cNvSpPr txBox="1"/>
                <p:nvPr/>
              </p:nvSpPr>
              <p:spPr>
                <a:xfrm>
                  <a:off x="3501008" y="873979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+</a:t>
                  </a:r>
                </a:p>
              </p:txBody>
            </p:sp>
            <p:sp>
              <p:nvSpPr>
                <p:cNvPr id="107" name="テキスト ボックス 106"/>
                <p:cNvSpPr txBox="1"/>
                <p:nvPr/>
              </p:nvSpPr>
              <p:spPr>
                <a:xfrm>
                  <a:off x="3291375" y="873979"/>
                  <a:ext cx="432048" cy="202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6326" b="1" dirty="0">
                      <a:latin typeface="Arial" pitchFamily="34" charset="0"/>
                      <a:cs typeface="Arial" pitchFamily="34" charset="0"/>
                    </a:rPr>
                    <a:t>-</a:t>
                  </a:r>
                </a:p>
              </p:txBody>
            </p:sp>
          </p:grpSp>
          <p:sp>
            <p:nvSpPr>
              <p:cNvPr id="9" name="二等辺三角形 8"/>
              <p:cNvSpPr/>
              <p:nvPr/>
            </p:nvSpPr>
            <p:spPr>
              <a:xfrm>
                <a:off x="5589240" y="3923928"/>
                <a:ext cx="144016" cy="144016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9489"/>
              </a:p>
            </p:txBody>
          </p:sp>
          <p:sp>
            <p:nvSpPr>
              <p:cNvPr id="120" name="テキスト ボックス 119"/>
              <p:cNvSpPr txBox="1"/>
              <p:nvPr/>
            </p:nvSpPr>
            <p:spPr>
              <a:xfrm>
                <a:off x="2313448" y="4023495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25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テキスト ボックス 120"/>
              <p:cNvSpPr txBox="1"/>
              <p:nvPr/>
            </p:nvSpPr>
            <p:spPr>
              <a:xfrm>
                <a:off x="2313448" y="3660280"/>
                <a:ext cx="648072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37</a:t>
                </a:r>
                <a:endParaRPr kumimoji="1" lang="ja-JP" altLang="en-US" sz="6326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80" name="グループ化 179"/>
          <p:cNvGrpSpPr/>
          <p:nvPr/>
        </p:nvGrpSpPr>
        <p:grpSpPr>
          <a:xfrm>
            <a:off x="6758608" y="4303175"/>
            <a:ext cx="17048611" cy="9489804"/>
            <a:chOff x="1282096" y="539552"/>
            <a:chExt cx="3234093" cy="1800200"/>
          </a:xfrm>
        </p:grpSpPr>
        <p:pic>
          <p:nvPicPr>
            <p:cNvPr id="3135" name="Picture 63" descr="C:\Users\Yuta Onodera\Desktop\20200315 MKN1 siPHB2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276872" y="1403648"/>
              <a:ext cx="2239317" cy="900000"/>
            </a:xfrm>
            <a:prstGeom prst="rect">
              <a:avLst/>
            </a:prstGeom>
            <a:noFill/>
            <a:scene3d>
              <a:camera prst="orthographicFront">
                <a:rot lat="0" lon="10800000" rev="0"/>
              </a:camera>
              <a:lightRig rig="threePt" dir="t"/>
            </a:scene3d>
          </p:spPr>
        </p:pic>
        <p:sp>
          <p:nvSpPr>
            <p:cNvPr id="23" name="二等辺三角形 22"/>
            <p:cNvSpPr/>
            <p:nvPr/>
          </p:nvSpPr>
          <p:spPr>
            <a:xfrm>
              <a:off x="4340720" y="1835696"/>
              <a:ext cx="144016" cy="144016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282096" y="539552"/>
              <a:ext cx="2146904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MDM2 (</a:t>
              </a:r>
              <a:r>
                <a:rPr lang="en-US" altLang="ja-JP" sz="6326" b="1" dirty="0">
                  <a:latin typeface="Arial" pitchFamily="34" charset="0"/>
                  <a:cs typeface="Arial" pitchFamily="34" charset="0"/>
                </a:rPr>
                <a:t>60-90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KDa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72816" y="1486689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kumimoji="1" lang="en-US" altLang="ja-JP" sz="6326" b="1" dirty="0" err="1">
                  <a:latin typeface="Arial" pitchFamily="34" charset="0"/>
                  <a:cs typeface="Arial" pitchFamily="34" charset="0"/>
                </a:rPr>
                <a:t>KDa</a:t>
              </a:r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)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700808" y="1714540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703096" y="1945804"/>
              <a:ext cx="648072" cy="2021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6326" b="1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6326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6" name="グループ化 175"/>
            <p:cNvGrpSpPr/>
            <p:nvPr/>
          </p:nvGrpSpPr>
          <p:grpSpPr>
            <a:xfrm>
              <a:off x="1763290" y="1061988"/>
              <a:ext cx="2121573" cy="382843"/>
              <a:chOff x="1763290" y="1162011"/>
              <a:chExt cx="2121573" cy="382843"/>
            </a:xfrm>
          </p:grpSpPr>
          <p:sp>
            <p:nvSpPr>
              <p:cNvPr id="109" name="テキスト ボックス 108"/>
              <p:cNvSpPr txBox="1"/>
              <p:nvPr/>
            </p:nvSpPr>
            <p:spPr>
              <a:xfrm>
                <a:off x="1763290" y="1342673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siPHB2</a:t>
                </a:r>
              </a:p>
            </p:txBody>
          </p:sp>
          <p:sp>
            <p:nvSpPr>
              <p:cNvPr id="110" name="テキスト ボックス 109"/>
              <p:cNvSpPr txBox="1"/>
              <p:nvPr/>
            </p:nvSpPr>
            <p:spPr>
              <a:xfrm>
                <a:off x="1763290" y="1162011"/>
                <a:ext cx="1067420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MG132</a:t>
                </a:r>
              </a:p>
            </p:txBody>
          </p:sp>
          <p:sp>
            <p:nvSpPr>
              <p:cNvPr id="111" name="テキスト ボックス 110"/>
              <p:cNvSpPr txBox="1"/>
              <p:nvPr/>
            </p:nvSpPr>
            <p:spPr>
              <a:xfrm>
                <a:off x="2843410" y="1342673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12" name="テキスト ボックス 111"/>
              <p:cNvSpPr txBox="1"/>
              <p:nvPr/>
            </p:nvSpPr>
            <p:spPr>
              <a:xfrm>
                <a:off x="3046545" y="1342673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13" name="テキスト ボックス 112"/>
              <p:cNvSpPr txBox="1"/>
              <p:nvPr/>
            </p:nvSpPr>
            <p:spPr>
              <a:xfrm>
                <a:off x="3249680" y="1342673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14" name="テキスト ボックス 113"/>
              <p:cNvSpPr txBox="1"/>
              <p:nvPr/>
            </p:nvSpPr>
            <p:spPr>
              <a:xfrm>
                <a:off x="3452815" y="1342673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15" name="テキスト ボックス 114"/>
              <p:cNvSpPr txBox="1"/>
              <p:nvPr/>
            </p:nvSpPr>
            <p:spPr>
              <a:xfrm>
                <a:off x="2843410" y="116201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16" name="テキスト ボックス 115"/>
              <p:cNvSpPr txBox="1"/>
              <p:nvPr/>
            </p:nvSpPr>
            <p:spPr>
              <a:xfrm>
                <a:off x="3046545" y="116201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17" name="テキスト ボックス 116"/>
              <p:cNvSpPr txBox="1"/>
              <p:nvPr/>
            </p:nvSpPr>
            <p:spPr>
              <a:xfrm>
                <a:off x="3452815" y="116201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18" name="テキスト ボックス 117"/>
              <p:cNvSpPr txBox="1"/>
              <p:nvPr/>
            </p:nvSpPr>
            <p:spPr>
              <a:xfrm>
                <a:off x="3249680" y="1162011"/>
                <a:ext cx="432048" cy="2021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326" b="1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sp>
          <p:nvSpPr>
            <p:cNvPr id="123" name="二等辺三角形 122"/>
            <p:cNvSpPr/>
            <p:nvPr/>
          </p:nvSpPr>
          <p:spPr>
            <a:xfrm>
              <a:off x="2986865" y="219573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24" name="二等辺三角形 123"/>
            <p:cNvSpPr/>
            <p:nvPr/>
          </p:nvSpPr>
          <p:spPr>
            <a:xfrm>
              <a:off x="3188599" y="219573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25" name="二等辺三角形 124"/>
            <p:cNvSpPr/>
            <p:nvPr/>
          </p:nvSpPr>
          <p:spPr>
            <a:xfrm>
              <a:off x="3390333" y="219573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sp>
          <p:nvSpPr>
            <p:cNvPr id="126" name="二等辺三角形 125"/>
            <p:cNvSpPr/>
            <p:nvPr/>
          </p:nvSpPr>
          <p:spPr>
            <a:xfrm>
              <a:off x="3592068" y="2195736"/>
              <a:ext cx="144016" cy="144016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489"/>
            </a:p>
          </p:txBody>
        </p:sp>
        <p:cxnSp>
          <p:nvCxnSpPr>
            <p:cNvPr id="178" name="直線コネクタ 177"/>
            <p:cNvCxnSpPr/>
            <p:nvPr/>
          </p:nvCxnSpPr>
          <p:spPr>
            <a:xfrm>
              <a:off x="2344688" y="1835696"/>
              <a:ext cx="144016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/>
            <p:cNvCxnSpPr/>
            <p:nvPr/>
          </p:nvCxnSpPr>
          <p:spPr>
            <a:xfrm>
              <a:off x="2348880" y="2074580"/>
              <a:ext cx="144016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2" name="テキスト ボックス 181"/>
          <p:cNvSpPr txBox="1"/>
          <p:nvPr/>
        </p:nvSpPr>
        <p:spPr>
          <a:xfrm>
            <a:off x="759185" y="9617466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LAS4010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994421" y="21384826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994421" y="35380753"/>
            <a:ext cx="8206672" cy="1552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489" b="1" dirty="0">
                <a:latin typeface="Arial" pitchFamily="34" charset="0"/>
                <a:cs typeface="Arial" pitchFamily="34" charset="0"/>
              </a:rPr>
              <a:t>[AI680</a:t>
            </a:r>
            <a:r>
              <a:rPr kumimoji="1" lang="en-US" altLang="ja-JP" sz="9489" b="1" dirty="0">
                <a:latin typeface="Arial" pitchFamily="34" charset="0"/>
                <a:cs typeface="Arial" pitchFamily="34" charset="0"/>
              </a:rPr>
              <a:t>]</a:t>
            </a:r>
            <a:endParaRPr kumimoji="1" lang="ja-JP" altLang="en-US" sz="9489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77</TotalTime>
  <Words>292</Words>
  <Application>Microsoft Office PowerPoint</Application>
  <PresentationFormat>ユーザー設定</PresentationFormat>
  <Paragraphs>181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yunaisec</dc:creator>
  <cp:lastModifiedBy>先端がん治療研究所</cp:lastModifiedBy>
  <cp:revision>150</cp:revision>
  <cp:lastPrinted>2021-03-18T10:18:15Z</cp:lastPrinted>
  <dcterms:created xsi:type="dcterms:W3CDTF">2020-03-19T06:53:50Z</dcterms:created>
  <dcterms:modified xsi:type="dcterms:W3CDTF">2021-05-03T14:29:10Z</dcterms:modified>
</cp:coreProperties>
</file>